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5304"/>
  </p:normalViewPr>
  <p:slideViewPr>
    <p:cSldViewPr snapToGrid="0" snapToObjects="1">
      <p:cViewPr varScale="1">
        <p:scale>
          <a:sx n="99" d="100"/>
          <a:sy n="99" d="100"/>
        </p:scale>
        <p:origin x="52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75DA86D-5193-4A42-9341-7CBAD7C27D0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B43D41C3-3497-3147-866D-21D2286B639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0AC1C9FD-2AD1-4E43-B07D-BD60082A13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AEB1CC-2B9B-BD43-A891-024A4E220EA9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54F6FABC-2267-7D46-8FD6-3109E54919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80AC0337-7BB2-6642-80C4-63F775BC7C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E0C2C-C0EF-A649-AA44-E4AE6A62A61B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555058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3FD7260-CE90-8945-92EB-3B89745CFB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49C2AD5F-3131-384F-BED0-A7A89256FC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A240706E-5F1F-F84B-BC8B-8D09DAC13C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AEB1CC-2B9B-BD43-A891-024A4E220EA9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EADF76D2-A8DB-6849-9D9D-8481401BBD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5D3E30D6-3439-294E-B80F-3E7B777192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E0C2C-C0EF-A649-AA44-E4AE6A62A61B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105463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D32F4C44-FB7B-EE4E-B7AE-B41936F4A6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D68ED497-73C9-624F-B4FB-92293F0110D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11226414-01F5-8842-BE24-9AF2430EF2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AEB1CC-2B9B-BD43-A891-024A4E220EA9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CD42B38F-805E-604F-B8F4-809F96928D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70852B32-D7AE-4C4B-ACA2-3B8D816031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E0C2C-C0EF-A649-AA44-E4AE6A62A61B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5870676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E30883E-499B-C448-9DAA-7BA79F1764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F0C7296E-34AC-C94D-8251-93C431D68B0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54B741B1-C0FB-014E-8CAE-BFAF596606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AEB1CC-2B9B-BD43-A891-024A4E220EA9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1E19AAD8-FE6E-1748-AA0D-80A0B4301E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372FCCBC-0351-5A42-98A3-CCECE9459C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E0C2C-C0EF-A649-AA44-E4AE6A62A61B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7311244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ECAC025-ECAE-FD42-8766-66238814D4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25C6F909-5109-984F-A56C-FEBFC452B5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6B54A45E-905D-9449-84FC-EA0CA3CAEC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AEB1CC-2B9B-BD43-A891-024A4E220EA9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4BF2EF4A-267A-0947-AAD1-13D6ED4A3D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E7116E39-EFA3-3444-8452-EFB09417F5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E0C2C-C0EF-A649-AA44-E4AE6A62A61B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1766570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A66D03B-AEE4-1544-AB69-E019D602B3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E4B5FCCF-A46B-5446-9015-51C53BFDBEF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5CDC7E5B-8412-D14A-B17D-4571361F1E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7D2ABE2C-BD18-8240-98DB-898305CF9D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AEB1CC-2B9B-BD43-A891-024A4E220EA9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F0C0CBC9-7C98-4040-BA8C-489C47AF5B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8E3E79BA-4DAD-B84B-98BB-724AC33137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E0C2C-C0EF-A649-AA44-E4AE6A62A61B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1382032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8EC23FD-BE5E-EF4C-AB28-4B5293C4B9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81AB397B-5199-2440-9E30-868B243632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18A397EF-1BBE-F44C-BA1A-C92064CB99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>
            <a:extLst>
              <a:ext uri="{FF2B5EF4-FFF2-40B4-BE49-F238E27FC236}">
                <a16:creationId xmlns:a16="http://schemas.microsoft.com/office/drawing/2014/main" id="{4F0AA30A-3F29-8140-A774-ACF88971623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Espaço Reservado para Conteúdo 5">
            <a:extLst>
              <a:ext uri="{FF2B5EF4-FFF2-40B4-BE49-F238E27FC236}">
                <a16:creationId xmlns:a16="http://schemas.microsoft.com/office/drawing/2014/main" id="{3EFA48D4-ABB6-A84E-92BA-CB3EE65DA3B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>
            <a:extLst>
              <a:ext uri="{FF2B5EF4-FFF2-40B4-BE49-F238E27FC236}">
                <a16:creationId xmlns:a16="http://schemas.microsoft.com/office/drawing/2014/main" id="{A98BD26C-0659-F64F-B1E3-40499D210E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AEB1CC-2B9B-BD43-A891-024A4E220EA9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8" name="Espaço Reservado para Rodapé 7">
            <a:extLst>
              <a:ext uri="{FF2B5EF4-FFF2-40B4-BE49-F238E27FC236}">
                <a16:creationId xmlns:a16="http://schemas.microsoft.com/office/drawing/2014/main" id="{CBB05D30-12AF-D34E-94FB-D481448864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>
            <a:extLst>
              <a:ext uri="{FF2B5EF4-FFF2-40B4-BE49-F238E27FC236}">
                <a16:creationId xmlns:a16="http://schemas.microsoft.com/office/drawing/2014/main" id="{C4EA729B-6B09-7A43-A438-237AE0BF6E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E0C2C-C0EF-A649-AA44-E4AE6A62A61B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2512882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F4C2CCF-AE13-F54B-894E-7A06087FF8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61EF8C2D-93A9-624D-8012-838F747D0F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AEB1CC-2B9B-BD43-A891-024A4E220EA9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6A2CB029-3A45-AB43-A25D-B7BFBDDF72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32A91C4A-2347-8D49-B8FD-819C2FE028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E0C2C-C0EF-A649-AA44-E4AE6A62A61B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7414872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>
            <a:extLst>
              <a:ext uri="{FF2B5EF4-FFF2-40B4-BE49-F238E27FC236}">
                <a16:creationId xmlns:a16="http://schemas.microsoft.com/office/drawing/2014/main" id="{BEDCB68F-C1A4-B546-BA5D-7EB984FFF3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AEB1CC-2B9B-BD43-A891-024A4E220EA9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3" name="Espaço Reservado para Rodapé 2">
            <a:extLst>
              <a:ext uri="{FF2B5EF4-FFF2-40B4-BE49-F238E27FC236}">
                <a16:creationId xmlns:a16="http://schemas.microsoft.com/office/drawing/2014/main" id="{B218E9E5-D2DD-5E48-8F04-7BB6425D95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63CD72C2-E2B8-394A-A33C-51E3C4C60F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E0C2C-C0EF-A649-AA44-E4AE6A62A61B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1512112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57D2344-CEA1-9349-9C37-1D11CC6C4D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1F9937E9-9A30-864F-BE0B-6564619D1DC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072E5479-45C1-9B4D-8292-5FD034355D7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1C3BF580-8185-CB42-AA24-732B488651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AEB1CC-2B9B-BD43-A891-024A4E220EA9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B214D7BE-EDC7-C44C-B393-3668F7A39D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5E74622C-8105-8743-A5E0-B9C047258C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E0C2C-C0EF-A649-AA44-E4AE6A62A61B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0308028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4A399B9-49F7-6044-9BDB-7B63AFA9BB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>
            <a:extLst>
              <a:ext uri="{FF2B5EF4-FFF2-40B4-BE49-F238E27FC236}">
                <a16:creationId xmlns:a16="http://schemas.microsoft.com/office/drawing/2014/main" id="{2F504A53-0E5A-2049-9AAA-EB723F8FD1E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E2335D89-8DE4-BB46-ADF7-B3ECC42D36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CE7AACA6-EC69-8B44-8530-10D522A6F3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AEB1CC-2B9B-BD43-A891-024A4E220EA9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D750BAFD-4C93-544D-81F7-6869550EE1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10AE17CF-35FF-F644-A5A5-D6D9211F9E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E0C2C-C0EF-A649-AA44-E4AE6A62A61B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1312433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>
            <a:extLst>
              <a:ext uri="{FF2B5EF4-FFF2-40B4-BE49-F238E27FC236}">
                <a16:creationId xmlns:a16="http://schemas.microsoft.com/office/drawing/2014/main" id="{1A9FE526-511F-104C-85AD-71B04A51C8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679DC16E-2493-334C-93F7-A113944970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EF3D510E-7541-6346-867B-DB4E8F395BF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AEB1CC-2B9B-BD43-A891-024A4E220EA9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3C93FCEA-71BA-4A4A-AF44-9CDF36AEA14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428697B3-C113-B945-A8F4-981BC6D3075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FE0C2C-C0EF-A649-AA44-E4AE6A62A61B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3754856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Chart&#10;&#10;Description automatically generated with medium confidence">
            <a:extLst>
              <a:ext uri="{FF2B5EF4-FFF2-40B4-BE49-F238E27FC236}">
                <a16:creationId xmlns:a16="http://schemas.microsoft.com/office/drawing/2014/main" id="{641A1364-5886-A044-9F68-56870FC2FBB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9397" y="1099779"/>
            <a:ext cx="11213206" cy="3488553"/>
          </a:xfrm>
          <a:prstGeom prst="rect">
            <a:avLst/>
          </a:prstGeom>
        </p:spPr>
      </p:pic>
      <p:sp>
        <p:nvSpPr>
          <p:cNvPr id="5" name="TextBox 26">
            <a:extLst>
              <a:ext uri="{FF2B5EF4-FFF2-40B4-BE49-F238E27FC236}">
                <a16:creationId xmlns:a16="http://schemas.microsoft.com/office/drawing/2014/main" id="{39AB823E-29FC-124F-BD71-FC831FB55578}"/>
              </a:ext>
            </a:extLst>
          </p:cNvPr>
          <p:cNvSpPr txBox="1"/>
          <p:nvPr/>
        </p:nvSpPr>
        <p:spPr>
          <a:xfrm>
            <a:off x="582393" y="4913409"/>
            <a:ext cx="96488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11: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ulsatility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dex (PI) – mean difference between all pre-eclampsia and </a:t>
            </a:r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control groups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5487389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8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Microsoft Office User</dc:creator>
  <cp:lastModifiedBy>Microsoft Office User</cp:lastModifiedBy>
  <cp:revision>1</cp:revision>
  <dcterms:created xsi:type="dcterms:W3CDTF">2022-02-06T21:31:34Z</dcterms:created>
  <dcterms:modified xsi:type="dcterms:W3CDTF">2022-02-06T21:32:45Z</dcterms:modified>
</cp:coreProperties>
</file>